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9" d="100"/>
          <a:sy n="99" d="100"/>
        </p:scale>
        <p:origin x="108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image" Target="../media/image6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83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Figure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1.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Multiple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Correspondence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Analysis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plot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considering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the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pt-PT" alt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livestock producers’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answers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to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biosecurity-related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questions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clustered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by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 country.</a:t>
            </a:r>
            <a:endParaRPr lang="en-GB" sz="28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43592" y="740664"/>
            <a:ext cx="7150215" cy="597763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727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terinaria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personal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ctiv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pment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nowledg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zoonosis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endParaRPr lang="en-GB" sz="2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77953" y="846561"/>
            <a:ext cx="7065534" cy="588480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alt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vestock produc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ecurity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cation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00952" y="637760"/>
            <a:ext cx="7189310" cy="6046427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altLang="ca-ES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ivestock produc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’</a:t>
            </a:r>
            <a:r>
              <a:rPr lang="pt-PT" alt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ecurity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ption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zoonosis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98470" y="755015"/>
            <a:ext cx="7202805" cy="601662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altLang="ca-ES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ivestock produc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’</a:t>
            </a:r>
            <a:r>
              <a:rPr lang="pt-PT" alt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personal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ctiv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pment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ntry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76337" y="820144"/>
            <a:ext cx="7032133" cy="5849739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83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altLang="ca-ES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ivestock produc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’</a:t>
            </a:r>
            <a:r>
              <a:rPr lang="pt-PT" alt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personal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ctiv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pment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cation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2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41582" y="933604"/>
            <a:ext cx="6898245" cy="5750583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altLang="ca-ES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ivestock produc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’</a:t>
            </a:r>
            <a:r>
              <a:rPr lang="pt-PT" altLang="ca-E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personal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ctiv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pment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ption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zoonosis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414" y="-4271793"/>
            <a:ext cx="5951255" cy="330143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1163" y="7729707"/>
            <a:ext cx="6069674" cy="340008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8814" y="-4119393"/>
            <a:ext cx="5951255" cy="330143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3563" y="7882107"/>
            <a:ext cx="6069674" cy="340008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1214" y="-3966993"/>
            <a:ext cx="5951255" cy="330143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963" y="8034507"/>
            <a:ext cx="6069674" cy="340008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3614" y="-3814593"/>
            <a:ext cx="5951255" cy="330143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8363" y="8186907"/>
            <a:ext cx="6069674" cy="340008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6414" y="962345"/>
            <a:ext cx="6812871" cy="5721842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a-ES" sz="18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terinaria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ecurity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ntry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68328" y="820144"/>
            <a:ext cx="7079227" cy="5864043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727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terinaria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ecurity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nowledg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zoonosis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endParaRPr lang="en-GB" sz="2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22333" y="903091"/>
            <a:ext cx="6963173" cy="5781096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9174" y="173813"/>
            <a:ext cx="11702034" cy="6727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.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idering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terinaria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wer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personal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ctive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pment-relat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s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ed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ca-E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ntry</a:t>
            </a:r>
            <a:r>
              <a:rPr lang="ca-E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endParaRPr lang="en-GB" sz="2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28211" y="846561"/>
            <a:ext cx="7048470" cy="586747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9</Words>
  <Application>WPS Presentation</Application>
  <PresentationFormat>Widescreen</PresentationFormat>
  <Paragraphs>2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22" baseType="lpstr">
      <vt:lpstr>Arial</vt:lpstr>
      <vt:lpstr>SimSun</vt:lpstr>
      <vt:lpstr>Wingdings</vt:lpstr>
      <vt:lpstr>Times New Roman</vt:lpstr>
      <vt:lpstr>Aptos</vt:lpstr>
      <vt:lpstr>Segoe UI</vt:lpstr>
      <vt:lpstr>Microsoft YaHei</vt:lpstr>
      <vt:lpstr>Arial Unicode MS</vt:lpstr>
      <vt:lpstr>Aptos Display</vt:lpstr>
      <vt:lpstr>Segoe UI Variable Display</vt:lpstr>
      <vt:lpstr>Calibri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falda Pedro Mil-Homens</dc:creator>
  <cp:lastModifiedBy>WPS_1738076318</cp:lastModifiedBy>
  <cp:revision>2</cp:revision>
  <dcterms:created xsi:type="dcterms:W3CDTF">2025-10-01T06:51:00Z</dcterms:created>
  <dcterms:modified xsi:type="dcterms:W3CDTF">2026-03-17T15:18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59135FC26CA4572B8C6CE48F449E4E4_12</vt:lpwstr>
  </property>
  <property fmtid="{D5CDD505-2E9C-101B-9397-08002B2CF9AE}" pid="3" name="KSOProductBuildVer">
    <vt:lpwstr>2070-12.2.0.23196</vt:lpwstr>
  </property>
</Properties>
</file>